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6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송재진(의생명과학부)" initials="송" lastIdx="0" clrIdx="0">
    <p:extLst>
      <p:ext uri="{19B8F6BF-5375-455C-9EA6-DF929625EA0E}">
        <p15:presenceInfo xmlns:p15="http://schemas.microsoft.com/office/powerpoint/2012/main" userId="S-1-5-21-1961260681-1744463731-1174482739-5253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25" autoAdjust="0"/>
    <p:restoredTop sz="96754" autoAdjust="0"/>
  </p:normalViewPr>
  <p:slideViewPr>
    <p:cSldViewPr>
      <p:cViewPr varScale="1">
        <p:scale>
          <a:sx n="84" d="100"/>
          <a:sy n="84" d="100"/>
        </p:scale>
        <p:origin x="3594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75" d="100"/>
          <a:sy n="75" d="100"/>
        </p:scale>
        <p:origin x="-2238" y="-96"/>
      </p:cViewPr>
      <p:guideLst>
        <p:guide orient="horz" pos="3126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7B5297-8AF9-4662-8439-A42EEAB29B89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FB9AF-191C-4A97-901B-B76D64413D3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48605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91B20B3F-015D-4D5C-8145-BEDC1A5A80D2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97F86E4C-FF9F-40A3-A151-3E4B9A7E95E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3350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7" name="TextBox 1196"/>
          <p:cNvSpPr txBox="1"/>
          <p:nvPr/>
        </p:nvSpPr>
        <p:spPr>
          <a:xfrm>
            <a:off x="188640" y="683568"/>
            <a:ext cx="22605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6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8" name="TextBox 1197"/>
          <p:cNvSpPr txBox="1"/>
          <p:nvPr/>
        </p:nvSpPr>
        <p:spPr>
          <a:xfrm>
            <a:off x="510619" y="2267744"/>
            <a:ext cx="15110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NL stat3 promoter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9" name="TextBox 1198"/>
          <p:cNvSpPr txBox="1"/>
          <p:nvPr/>
        </p:nvSpPr>
        <p:spPr>
          <a:xfrm>
            <a:off x="476672" y="2771800"/>
            <a:ext cx="5724644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79   TTAAGTGGG GTGACACCTG GGGACCGCCT AAGTGGCTGA TTCCCACGTG GTAAGGAGCT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420  CACAAACTCG CCCCCACGTG GTGC</a:t>
            </a:r>
            <a:r>
              <a:rPr lang="en-US" altLang="ko-KR" sz="1000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GG CCGGGAAAAG GGAGAGCGGG CAGAAGCGAG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60  CCGTATCAGG GCATTTAAAG TGTCTTGACG TCACGCACTG CCAGGAACTC AGCTGAGTTT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300  TCAGCAGGAC ATTCCGCTAA TGTCTCCTCC CTCCCCCCGG GCTTTTTTGT AAGCTAGGCC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40  TCTGCGCGTC CCTTGGTCGC GGAGGGAGGA GCACAAAGCT CTCAGAACAG CCAACTCAGG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80  GAGGTGTGCC CAGAGCTCTC GACCCCGCCT TCTCTCCTAG AGGCGTTTTT CATTGGTTAG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20  TGGGCGGGGC TTAGGAAGTA CAGCGCTCGC CCGGAGGCCT CAGGGTGGCC TAGCCAGCTG</a:t>
            </a:r>
          </a:p>
          <a:p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-60  GCCATTCCTT AATTATGCAT GGAGGCGTGT CTTGGCCAGT GGCGGCTGGG TGGGGATTGG</a:t>
            </a:r>
          </a:p>
          <a:p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1  CTGGAGGGGC TGTAATTCAG CGGTTTCCGG AGCTGCAGTG TAGACAGGGA GGGGGAACCT</a:t>
            </a:r>
          </a:p>
          <a:p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61  G</a:t>
            </a:r>
            <a:endParaRPr lang="ko-KR" alt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81</TotalTime>
  <Words>83</Words>
  <Application>Microsoft Office PowerPoint</Application>
  <PresentationFormat>화면 슬라이드 쇼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ourier New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1523</cp:revision>
  <cp:lastPrinted>2019-05-07T06:31:19Z</cp:lastPrinted>
  <dcterms:created xsi:type="dcterms:W3CDTF">2016-01-12T05:31:29Z</dcterms:created>
  <dcterms:modified xsi:type="dcterms:W3CDTF">2019-05-29T08:09:08Z</dcterms:modified>
</cp:coreProperties>
</file>